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0" r:id="rId2"/>
    <p:sldId id="265" r:id="rId3"/>
    <p:sldId id="267" r:id="rId4"/>
    <p:sldId id="268" r:id="rId5"/>
    <p:sldId id="269" r:id="rId6"/>
    <p:sldId id="271" r:id="rId7"/>
    <p:sldId id="272" r:id="rId8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76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0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 sz="16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de III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9638828482907117"/>
          <c:y val="0.16156854778902022"/>
          <c:w val="0.77696450699878994"/>
          <c:h val="0.569187834935866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ach 1,5J'!$E$41</c:f>
              <c:strCache>
                <c:ptCount val="1"/>
                <c:pt idx="0">
                  <c:v>healthy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ach 1,5J'!$F$44:$G$44</c:f>
                <c:numCache>
                  <c:formatCode>General</c:formatCode>
                  <c:ptCount val="2"/>
                  <c:pt idx="0">
                    <c:v>2.1340859674967847</c:v>
                  </c:pt>
                  <c:pt idx="1">
                    <c:v>1.17497163086320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ach 1,5J'!$F$38:$H$40</c:f>
              <c:strCache>
                <c:ptCount val="2"/>
                <c:pt idx="0">
                  <c:v>CD94+</c:v>
                </c:pt>
                <c:pt idx="1">
                  <c:v>CD69+</c:v>
                </c:pt>
              </c:strCache>
            </c:strRef>
          </c:cat>
          <c:val>
            <c:numRef>
              <c:f>'nach 1,5J'!$F$41:$G$41</c:f>
              <c:numCache>
                <c:formatCode>General</c:formatCode>
                <c:ptCount val="2"/>
                <c:pt idx="0">
                  <c:v>5.2181249999999988</c:v>
                </c:pt>
                <c:pt idx="1">
                  <c:v>1.32874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E52-4C72-BE4F-AF351D80EC19}"/>
            </c:ext>
          </c:extLst>
        </c:ser>
        <c:ser>
          <c:idx val="1"/>
          <c:order val="1"/>
          <c:tx>
            <c:strRef>
              <c:f>'nach 1,5J'!$E$42</c:f>
              <c:strCache>
                <c:ptCount val="1"/>
                <c:pt idx="0">
                  <c:v>progression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ach 1,5J'!$F$45:$G$45</c:f>
                <c:numCache>
                  <c:formatCode>General</c:formatCode>
                  <c:ptCount val="2"/>
                  <c:pt idx="0">
                    <c:v>3.0226864431054268</c:v>
                  </c:pt>
                  <c:pt idx="1">
                    <c:v>1.66333333333333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ach 1,5J'!$F$38:$H$40</c:f>
              <c:strCache>
                <c:ptCount val="2"/>
                <c:pt idx="0">
                  <c:v>CD94+</c:v>
                </c:pt>
                <c:pt idx="1">
                  <c:v>CD69+</c:v>
                </c:pt>
              </c:strCache>
            </c:strRef>
          </c:cat>
          <c:val>
            <c:numRef>
              <c:f>'nach 1,5J'!$F$42:$G$42</c:f>
              <c:numCache>
                <c:formatCode>General</c:formatCode>
                <c:ptCount val="2"/>
                <c:pt idx="0">
                  <c:v>5.3433333333333337</c:v>
                </c:pt>
                <c:pt idx="1">
                  <c:v>1.6633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E52-4C72-BE4F-AF351D80EC19}"/>
            </c:ext>
          </c:extLst>
        </c:ser>
        <c:ser>
          <c:idx val="2"/>
          <c:order val="2"/>
          <c:tx>
            <c:strRef>
              <c:f>'nach 1,5J'!$E$43</c:f>
              <c:strCache>
                <c:ptCount val="1"/>
                <c:pt idx="0">
                  <c:v>no progressio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ach 1,5J'!$F$46:$G$46</c:f>
                <c:numCache>
                  <c:formatCode>General</c:formatCode>
                  <c:ptCount val="2"/>
                  <c:pt idx="0">
                    <c:v>5.5235106087020842</c:v>
                  </c:pt>
                  <c:pt idx="1">
                    <c:v>2.44434551567490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ach 1,5J'!$F$38:$H$40</c:f>
              <c:strCache>
                <c:ptCount val="2"/>
                <c:pt idx="0">
                  <c:v>CD94+</c:v>
                </c:pt>
                <c:pt idx="1">
                  <c:v>CD69+</c:v>
                </c:pt>
              </c:strCache>
            </c:strRef>
          </c:cat>
          <c:val>
            <c:numRef>
              <c:f>'nach 1,5J'!$F$43:$G$43</c:f>
              <c:numCache>
                <c:formatCode>General</c:formatCode>
                <c:ptCount val="2"/>
                <c:pt idx="0">
                  <c:v>6.4577777777777765</c:v>
                </c:pt>
                <c:pt idx="1">
                  <c:v>2.3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E52-4C72-BE4F-AF351D80EC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5792160"/>
        <c:axId val="455787456"/>
      </c:barChart>
      <c:catAx>
        <c:axId val="455792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5787456"/>
        <c:crosses val="autoZero"/>
        <c:auto val="1"/>
        <c:lblAlgn val="ctr"/>
        <c:lblOffset val="100"/>
        <c:noMultiLvlLbl val="0"/>
      </c:catAx>
      <c:valAx>
        <c:axId val="455787456"/>
        <c:scaling>
          <c:orientation val="minMax"/>
          <c:max val="1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180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K [%]</a:t>
                </a:r>
                <a:endParaRPr lang="de-DE" sz="180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3092279088672407E-2"/>
              <c:y val="0.272305211848518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57921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835530733076967"/>
          <c:y val="0.90103600379190929"/>
          <c:w val="0.78142892022218158"/>
          <c:h val="7.439397163806613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 sz="1600" dirty="0">
                <a:solidFill>
                  <a:sysClr val="windowText" lastClr="000000"/>
                </a:solidFill>
              </a:rPr>
              <a:t>grade IV</a:t>
            </a:r>
          </a:p>
        </c:rich>
      </c:tx>
      <c:layout>
        <c:manualLayout>
          <c:xMode val="edge"/>
          <c:yMode val="edge"/>
          <c:x val="0.42470221481908171"/>
          <c:y val="1.43884892086330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9595129859128305"/>
          <c:y val="7.8921052134670211E-2"/>
          <c:w val="0.77502117801481307"/>
          <c:h val="0.599942219452784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IV!$AJ$78</c:f>
              <c:strCache>
                <c:ptCount val="1"/>
                <c:pt idx="0">
                  <c:v>healthy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IV!$AK$81:$AL$81</c:f>
                <c:numCache>
                  <c:formatCode>General</c:formatCode>
                  <c:ptCount val="2"/>
                  <c:pt idx="0">
                    <c:v>2.1340859674967847</c:v>
                  </c:pt>
                  <c:pt idx="1">
                    <c:v>1.17497163086320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IV!$AK$77:$AL$77</c:f>
              <c:strCache>
                <c:ptCount val="2"/>
                <c:pt idx="0">
                  <c:v>CD94+</c:v>
                </c:pt>
                <c:pt idx="1">
                  <c:v>CD69+</c:v>
                </c:pt>
              </c:strCache>
            </c:strRef>
          </c:cat>
          <c:val>
            <c:numRef>
              <c:f>IV!$AK$78:$AL$78</c:f>
              <c:numCache>
                <c:formatCode>0.00</c:formatCode>
                <c:ptCount val="2"/>
                <c:pt idx="0">
                  <c:v>5.2181249999999988</c:v>
                </c:pt>
                <c:pt idx="1">
                  <c:v>1.32874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F12-4AAF-97B3-42B670D71D4B}"/>
            </c:ext>
          </c:extLst>
        </c:ser>
        <c:ser>
          <c:idx val="1"/>
          <c:order val="1"/>
          <c:tx>
            <c:strRef>
              <c:f>IV!$AJ$79</c:f>
              <c:strCache>
                <c:ptCount val="1"/>
                <c:pt idx="0">
                  <c:v>progression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IV!$AK$82:$AL$82</c:f>
                <c:numCache>
                  <c:formatCode>General</c:formatCode>
                  <c:ptCount val="2"/>
                  <c:pt idx="0">
                    <c:v>5.2134552415414079</c:v>
                  </c:pt>
                  <c:pt idx="1">
                    <c:v>1.41417624235610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IV!$AK$77:$AL$77</c:f>
              <c:strCache>
                <c:ptCount val="2"/>
                <c:pt idx="0">
                  <c:v>CD94+</c:v>
                </c:pt>
                <c:pt idx="1">
                  <c:v>CD69+</c:v>
                </c:pt>
              </c:strCache>
            </c:strRef>
          </c:cat>
          <c:val>
            <c:numRef>
              <c:f>IV!$AK$79:$AL$79</c:f>
              <c:numCache>
                <c:formatCode>General</c:formatCode>
                <c:ptCount val="2"/>
                <c:pt idx="0">
                  <c:v>6.8940000000000001</c:v>
                </c:pt>
                <c:pt idx="1">
                  <c:v>2.46777777777777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F12-4AAF-97B3-42B670D71D4B}"/>
            </c:ext>
          </c:extLst>
        </c:ser>
        <c:ser>
          <c:idx val="2"/>
          <c:order val="2"/>
          <c:tx>
            <c:strRef>
              <c:f>IV!$AJ$80</c:f>
              <c:strCache>
                <c:ptCount val="1"/>
                <c:pt idx="0">
                  <c:v>no progressio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IV!$AK$83:$AL$83</c:f>
                <c:numCache>
                  <c:formatCode>General</c:formatCode>
                  <c:ptCount val="2"/>
                  <c:pt idx="0">
                    <c:v>5.6209045878971624</c:v>
                  </c:pt>
                  <c:pt idx="1">
                    <c:v>3.34348034936065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IV!$AK$77:$AL$77</c:f>
              <c:strCache>
                <c:ptCount val="2"/>
                <c:pt idx="0">
                  <c:v>CD94+</c:v>
                </c:pt>
                <c:pt idx="1">
                  <c:v>CD69+</c:v>
                </c:pt>
              </c:strCache>
            </c:strRef>
          </c:cat>
          <c:val>
            <c:numRef>
              <c:f>IV!$AK$80:$AL$80</c:f>
              <c:numCache>
                <c:formatCode>General</c:formatCode>
                <c:ptCount val="2"/>
                <c:pt idx="0">
                  <c:v>7.090357142857143</c:v>
                </c:pt>
                <c:pt idx="1">
                  <c:v>3.82357142857142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F12-4AAF-97B3-42B670D71D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5795688"/>
        <c:axId val="455796080"/>
      </c:barChart>
      <c:catAx>
        <c:axId val="455795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5796080"/>
        <c:crosses val="autoZero"/>
        <c:auto val="1"/>
        <c:lblAlgn val="ctr"/>
        <c:lblOffset val="100"/>
        <c:noMultiLvlLbl val="0"/>
      </c:catAx>
      <c:valAx>
        <c:axId val="455796080"/>
        <c:scaling>
          <c:orientation val="minMax"/>
          <c:max val="1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180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>
                  <a:defRPr sz="1800">
                    <a:solidFill>
                      <a:sysClr val="windowText" lastClr="000000"/>
                    </a:solidFill>
                  </a:defRPr>
                </a:pPr>
                <a:r>
                  <a:rPr lang="de-DE" sz="180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K [%]</a:t>
                </a:r>
                <a:endParaRPr lang="de-DE" sz="180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94028965803734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57956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351706036745406"/>
          <c:y val="0.880126179879689"/>
          <c:w val="0.76471644781702719"/>
          <c:h val="9.50290996234166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600" baseline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de IV</a:t>
            </a:r>
            <a:endParaRPr lang="de-DE" sz="16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51219358774183077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23126165285351247"/>
          <c:y val="0.12851313904487038"/>
          <c:w val="0.76628745674077681"/>
          <c:h val="0.595862429546904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V-Cortison'!$I$3</c:f>
              <c:strCache>
                <c:ptCount val="1"/>
                <c:pt idx="0">
                  <c:v>glucocorticoid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V-Cortison'!$J$5:$K$5</c:f>
                <c:numCache>
                  <c:formatCode>General</c:formatCode>
                  <c:ptCount val="2"/>
                  <c:pt idx="0">
                    <c:v>4.4094309225347947</c:v>
                  </c:pt>
                  <c:pt idx="1">
                    <c:v>2.21894101823916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V-Cortison'!$J$2:$K$2</c:f>
              <c:strCache>
                <c:ptCount val="2"/>
                <c:pt idx="0">
                  <c:v>CD94+</c:v>
                </c:pt>
                <c:pt idx="1">
                  <c:v>CD69+</c:v>
                </c:pt>
              </c:strCache>
            </c:strRef>
          </c:cat>
          <c:val>
            <c:numRef>
              <c:f>'IV-Cortison'!$J$3:$K$3</c:f>
              <c:numCache>
                <c:formatCode>General</c:formatCode>
                <c:ptCount val="2"/>
                <c:pt idx="0">
                  <c:v>5.4708333333333341</c:v>
                </c:pt>
                <c:pt idx="1">
                  <c:v>2.86416666666666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270-4961-915A-062C580E2C06}"/>
            </c:ext>
          </c:extLst>
        </c:ser>
        <c:ser>
          <c:idx val="1"/>
          <c:order val="1"/>
          <c:tx>
            <c:strRef>
              <c:f>'IV-Cortison'!$I$4</c:f>
              <c:strCache>
                <c:ptCount val="1"/>
                <c:pt idx="0">
                  <c:v>no glucocorticoid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V-Cortison'!$J$6:$K$6</c:f>
                <c:numCache>
                  <c:formatCode>General</c:formatCode>
                  <c:ptCount val="2"/>
                  <c:pt idx="0">
                    <c:v>6.2545146118866057</c:v>
                  </c:pt>
                  <c:pt idx="1">
                    <c:v>5.36970534423174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V-Cortison'!$J$2:$K$2</c:f>
              <c:strCache>
                <c:ptCount val="2"/>
                <c:pt idx="0">
                  <c:v>CD94+</c:v>
                </c:pt>
                <c:pt idx="1">
                  <c:v>CD69+</c:v>
                </c:pt>
              </c:strCache>
            </c:strRef>
          </c:cat>
          <c:val>
            <c:numRef>
              <c:f>'IV-Cortison'!$J$4:$K$4</c:f>
              <c:numCache>
                <c:formatCode>General</c:formatCode>
                <c:ptCount val="2"/>
                <c:pt idx="0">
                  <c:v>8.2530303030303021</c:v>
                </c:pt>
                <c:pt idx="1">
                  <c:v>4.5549999999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270-4961-915A-062C580E2C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5797256"/>
        <c:axId val="455788240"/>
      </c:barChart>
      <c:catAx>
        <c:axId val="455797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5788240"/>
        <c:crosses val="autoZero"/>
        <c:auto val="1"/>
        <c:lblAlgn val="ctr"/>
        <c:lblOffset val="100"/>
        <c:noMultiLvlLbl val="0"/>
      </c:catAx>
      <c:valAx>
        <c:axId val="455788240"/>
        <c:scaling>
          <c:orientation val="minMax"/>
          <c:max val="1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0" i="0" baseline="0" dirty="0" smtClean="0">
                    <a:solidFill>
                      <a:sysClr val="windowText" lastClr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K [%]</a:t>
                </a:r>
                <a:endParaRPr lang="de-DE" dirty="0">
                  <a:solidFill>
                    <a:sysClr val="windowText" lastClr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3216027941307927E-2"/>
              <c:y val="0.3009275066618926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579725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2509746024394009"/>
          <c:y val="0.89733133069348991"/>
          <c:w val="0.70421684421800212"/>
          <c:h val="0.10179114893875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C76875-9956-4EAE-8931-9593DDFB6F9E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757982-29F9-4312-8C55-8820EEEE71B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787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88AA22-29A7-49D2-A4AC-896368028AF3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10920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99ACBF86-98A0-4994-9787-0AE12D0913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="" xmlns:a16="http://schemas.microsoft.com/office/drawing/2014/main" id="{022A7F73-71EC-4BD7-BA94-163693D53C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6ABD2E05-6CED-40CC-9A53-ECD965E87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19E8C090-3E91-4228-9E5C-6D2C52E88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D7D858DE-2730-4E59-975C-24E2D1FC6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8556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42F113F5-DFBF-4DF3-8092-174234DB35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="" xmlns:a16="http://schemas.microsoft.com/office/drawing/2014/main" id="{FE3AFDBF-EA69-4017-BF6A-F820FE78D5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719C1559-871C-4343-AB9C-55B633488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FB8DCBDB-50BE-454A-9386-25FDA332E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68118CB2-0390-41C9-8FA7-3D9F964A3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4017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="" xmlns:a16="http://schemas.microsoft.com/office/drawing/2014/main" id="{9D42D21A-2253-427E-9E99-8486A65EF9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="" xmlns:a16="http://schemas.microsoft.com/office/drawing/2014/main" id="{4B3C3F5A-817A-4311-8DBC-579D366FE9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DD82A9F5-E057-476B-B642-1CE9D7374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73C031A6-5B43-4277-9628-38C15B1EF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5F667CD2-118F-44D1-ABD4-ED92F96B7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3550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DA9A8821-EDE4-4CF4-A7A9-2E4070F28C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="" xmlns:a16="http://schemas.microsoft.com/office/drawing/2014/main" id="{B3C815E9-8C6F-479F-ABB1-5C08B47356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00955964-4DB3-4A31-A0EC-CF3D8F3BF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3346363B-7B3A-4E3C-B13B-600063786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9DB966B1-C380-445A-8FA9-5EB48950E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3535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65D99E3A-4237-434E-A6DD-2A37A98096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="" xmlns:a16="http://schemas.microsoft.com/office/drawing/2014/main" id="{A31DAF5B-56C8-4F25-BB82-41B2F93BB0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68BE2885-0762-48F3-8934-D7E544A16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3C0B1FBA-333C-4263-AD30-223C58626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C5DC0035-344F-46C0-A5EE-56A8972A5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7473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C7E2BE2C-EB16-4503-AA08-00BD5ACE4E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="" xmlns:a16="http://schemas.microsoft.com/office/drawing/2014/main" id="{1D4AEE45-4746-4865-84B5-83B632DBA4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="" xmlns:a16="http://schemas.microsoft.com/office/drawing/2014/main" id="{4E2AC869-13E5-4864-83CE-202A1FC012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="" xmlns:a16="http://schemas.microsoft.com/office/drawing/2014/main" id="{5C3069DC-A179-43AE-BF1F-B1FE4601F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="" xmlns:a16="http://schemas.microsoft.com/office/drawing/2014/main" id="{954FCAA1-6DCD-4AC2-8D5D-E41B632B6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="" xmlns:a16="http://schemas.microsoft.com/office/drawing/2014/main" id="{B45962A4-4755-4BDD-A04D-C6C3D31A6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5435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CF26CD0A-9E30-4D52-918F-4B1433462F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="" xmlns:a16="http://schemas.microsoft.com/office/drawing/2014/main" id="{5589B513-A86C-47D2-884B-8F66545661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="" xmlns:a16="http://schemas.microsoft.com/office/drawing/2014/main" id="{3720571B-B857-47A2-96F0-06012775E2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="" xmlns:a16="http://schemas.microsoft.com/office/drawing/2014/main" id="{AA577F21-3718-4DBE-9BD6-F7211B99F2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="" xmlns:a16="http://schemas.microsoft.com/office/drawing/2014/main" id="{FFC2BE91-7ABE-4B20-A642-7E02D35A17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="" xmlns:a16="http://schemas.microsoft.com/office/drawing/2014/main" id="{A320D6E2-8836-4669-904F-E55CACCF6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="" xmlns:a16="http://schemas.microsoft.com/office/drawing/2014/main" id="{E85D4876-35F9-4F2B-8230-6E991E403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="" xmlns:a16="http://schemas.microsoft.com/office/drawing/2014/main" id="{8D3E4BBE-FC31-4E38-A801-E546C7842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6850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AE098D40-650F-4FA2-A9AC-193E70A86D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="" xmlns:a16="http://schemas.microsoft.com/office/drawing/2014/main" id="{277D483D-1E54-4CF5-A27C-AC40DAEC38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="" xmlns:a16="http://schemas.microsoft.com/office/drawing/2014/main" id="{507C96F4-90C4-464D-8365-C0EE5450C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="" xmlns:a16="http://schemas.microsoft.com/office/drawing/2014/main" id="{55A44503-394C-44B6-BE26-BD64CFFAA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0559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="" xmlns:a16="http://schemas.microsoft.com/office/drawing/2014/main" id="{E33401DF-6375-47AF-91FA-568881E65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="" xmlns:a16="http://schemas.microsoft.com/office/drawing/2014/main" id="{4C593854-ACE5-4CBE-9262-062DC05F2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="" xmlns:a16="http://schemas.microsoft.com/office/drawing/2014/main" id="{7398BFF5-2AA4-4036-AF4A-4A67CCCBB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4286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53BC7606-5CFB-415A-AE19-825E99896E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="" xmlns:a16="http://schemas.microsoft.com/office/drawing/2014/main" id="{CC581A87-9623-471D-8918-3CDC016195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="" xmlns:a16="http://schemas.microsoft.com/office/drawing/2014/main" id="{90EE199F-61B8-4111-B2A1-411CD36FCB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="" xmlns:a16="http://schemas.microsoft.com/office/drawing/2014/main" id="{9B99DBC1-337C-4F6D-B8E4-EEB04C1B8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="" xmlns:a16="http://schemas.microsoft.com/office/drawing/2014/main" id="{FBB38C61-53B4-4E6F-AA37-819181011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="" xmlns:a16="http://schemas.microsoft.com/office/drawing/2014/main" id="{B157088D-E76C-4236-B076-31B011245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59632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91A2C803-B134-42F6-9FDD-9A477F4A86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="" xmlns:a16="http://schemas.microsoft.com/office/drawing/2014/main" id="{E8DA3C1B-E74F-4C2F-8069-F1B5A494A2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="" xmlns:a16="http://schemas.microsoft.com/office/drawing/2014/main" id="{4C1212B6-6BCF-498B-93B3-1F73ED0B5A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="" xmlns:a16="http://schemas.microsoft.com/office/drawing/2014/main" id="{93852094-D1B7-4C63-A5F5-66764FBEA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="" xmlns:a16="http://schemas.microsoft.com/office/drawing/2014/main" id="{6BE6C9F7-2FAA-41EB-8947-328E0FB9AE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="" xmlns:a16="http://schemas.microsoft.com/office/drawing/2014/main" id="{5C9EC03C-4E16-4FD0-9A7D-8520B1CC4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6462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="" xmlns:a16="http://schemas.microsoft.com/office/drawing/2014/main" id="{2BE7ED7A-FAB7-4236-B104-840E43354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="" xmlns:a16="http://schemas.microsoft.com/office/drawing/2014/main" id="{0CD7A99D-8CDC-449E-981B-05620726DA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D08A94DF-9736-4264-8C2A-63DD12DF70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B1AA7C-4DA0-4911-8EDC-2113AAFF405A}" type="datetimeFigureOut">
              <a:rPr lang="de-DE" smtClean="0"/>
              <a:t>09.04.20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6D48D9E4-FDB2-4DFD-8C64-F529F09B15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4BE5091A-F425-45BF-BA6F-B01AA95D24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3CE0C-5067-4D8D-9D9E-4DD9BC07ED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9738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chart" Target="../charts/chart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03682" y="394692"/>
            <a:ext cx="10795247" cy="6463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gends</a:t>
            </a:r>
            <a:r>
              <a:rPr lang="de-D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endParaRPr lang="de-DE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: FACS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lected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ir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SC/SSC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Events in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1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tometric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B, T, and NK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a FACS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strument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NK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fined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ulti-color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cribed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s and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od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tion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3-/CD56+, CD56+/CD94+, CD3-/CD69+, CD56+/CD69+. </a:t>
            </a:r>
          </a:p>
          <a:p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tter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tter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CD3+, CD3+CD4+, CD3+/CD8+ T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CD56+/CD94+, CD3-/CD69+, CD3-/CD56+, CD3-/NKG2D+, CD3-/NKp30+, CD3-/NKp46+ NK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=15) versus grade II (n=6), grade III (n=13) and grade IV (n=56)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ioma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ipheral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All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tlier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lculation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*p&lt;0.05. </a:t>
            </a:r>
            <a:endParaRPr lang="de-DE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de-DE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 Percentage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CD3-/CD94+, CD3-/CD69+ NK cells in glioma patients grade III with (n=3) and without tumor progression (n=9) within 18 months after diagnosis compared to healthy controls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llis; n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. Percentage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CD3-/CD94+ and CD3-/CD69+ NK cells in glioma patients grade IV with (n=10) and without tumor progression (n=27) within 6 months after diagnosis compared to healthy controls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llis; **p&lt;0.01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B. Percentage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CD3-/CD94+ and CD3-/CD69+ NK cells in glioma patients grade IV with (n=12) and without (n=33) glucocorticoid treatment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llis; n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C.</a:t>
            </a:r>
          </a:p>
          <a:p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 Kaplan-Meie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he overall survival (OS) in glioblastoma patients with the frequency of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-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56+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and CD3-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94+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NK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below and above a threshold of 7.5% and 5%, respectively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grank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=0.05). 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/>
              <a:t> 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5339642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feld 12"/>
          <p:cNvSpPr txBox="1"/>
          <p:nvPr/>
        </p:nvSpPr>
        <p:spPr>
          <a:xfrm>
            <a:off x="9481001" y="6488668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1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4350" y="1172011"/>
            <a:ext cx="5763319" cy="39857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4" name="Gerader Verbinder 13"/>
          <p:cNvCxnSpPr/>
          <p:nvPr/>
        </p:nvCxnSpPr>
        <p:spPr>
          <a:xfrm flipV="1">
            <a:off x="1851578" y="1172011"/>
            <a:ext cx="5386091" cy="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Rechteck 14"/>
          <p:cNvSpPr/>
          <p:nvPr/>
        </p:nvSpPr>
        <p:spPr>
          <a:xfrm>
            <a:off x="8589119" y="4320589"/>
            <a:ext cx="1123052" cy="304800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de-DE" sz="16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CS </a:t>
            </a:r>
            <a:r>
              <a:rPr lang="de-DE" sz="1600" dirty="0" err="1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sis</a:t>
            </a:r>
            <a:endParaRPr lang="de-DE" sz="16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Rechteck 15">
            <a:extLst>
              <a:ext uri="{FF2B5EF4-FFF2-40B4-BE49-F238E27FC236}">
                <a16:creationId xmlns="" xmlns:a16="http://schemas.microsoft.com/office/drawing/2014/main" id="{1F862F14-80F7-472E-AAA1-586BBBCF697B}"/>
              </a:ext>
            </a:extLst>
          </p:cNvPr>
          <p:cNvSpPr/>
          <p:nvPr/>
        </p:nvSpPr>
        <p:spPr>
          <a:xfrm>
            <a:off x="5124590" y="4286444"/>
            <a:ext cx="2113079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R1: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lymphocyt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gat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600" dirty="0"/>
          </a:p>
          <a:p>
            <a:endParaRPr lang="de-DE" sz="1600" dirty="0"/>
          </a:p>
        </p:txBody>
      </p:sp>
      <p:sp>
        <p:nvSpPr>
          <p:cNvPr id="17" name="Rechteck 16">
            <a:extLst>
              <a:ext uri="{FF2B5EF4-FFF2-40B4-BE49-F238E27FC236}">
                <a16:creationId xmlns="" xmlns:a16="http://schemas.microsoft.com/office/drawing/2014/main" id="{1F862F14-80F7-472E-AAA1-586BBBCF697B}"/>
              </a:ext>
            </a:extLst>
          </p:cNvPr>
          <p:cNvSpPr/>
          <p:nvPr/>
        </p:nvSpPr>
        <p:spPr>
          <a:xfrm>
            <a:off x="4939638" y="3466835"/>
            <a:ext cx="1965603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3: </a:t>
            </a:r>
            <a:r>
              <a:rPr lang="de-D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nocyte</a:t>
            </a:r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te</a:t>
            </a:r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600" dirty="0"/>
          </a:p>
          <a:p>
            <a:endParaRPr lang="de-DE" sz="1600" dirty="0"/>
          </a:p>
        </p:txBody>
      </p:sp>
      <p:sp>
        <p:nvSpPr>
          <p:cNvPr id="18" name="Rechteck 17">
            <a:extLst>
              <a:ext uri="{FF2B5EF4-FFF2-40B4-BE49-F238E27FC236}">
                <a16:creationId xmlns="" xmlns:a16="http://schemas.microsoft.com/office/drawing/2014/main" id="{1F862F14-80F7-472E-AAA1-586BBBCF697B}"/>
              </a:ext>
            </a:extLst>
          </p:cNvPr>
          <p:cNvSpPr/>
          <p:nvPr/>
        </p:nvSpPr>
        <p:spPr>
          <a:xfrm>
            <a:off x="1851578" y="3466835"/>
            <a:ext cx="74251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bris</a:t>
            </a:r>
            <a:endParaRPr lang="de-DE" sz="1600" dirty="0"/>
          </a:p>
        </p:txBody>
      </p:sp>
      <p:sp>
        <p:nvSpPr>
          <p:cNvPr id="19" name="Rechteck 18">
            <a:extLst>
              <a:ext uri="{FF2B5EF4-FFF2-40B4-BE49-F238E27FC236}">
                <a16:creationId xmlns="" xmlns:a16="http://schemas.microsoft.com/office/drawing/2014/main" id="{1F862F14-80F7-472E-AAA1-586BBBCF697B}"/>
              </a:ext>
            </a:extLst>
          </p:cNvPr>
          <p:cNvSpPr/>
          <p:nvPr/>
        </p:nvSpPr>
        <p:spPr>
          <a:xfrm>
            <a:off x="5124590" y="2472256"/>
            <a:ext cx="2193229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2: </a:t>
            </a:r>
            <a:r>
              <a:rPr lang="de-D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anulocyte</a:t>
            </a:r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te</a:t>
            </a:r>
            <a:r>
              <a:rPr 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600" dirty="0"/>
          </a:p>
          <a:p>
            <a:endParaRPr lang="de-DE" sz="1600" dirty="0"/>
          </a:p>
        </p:txBody>
      </p:sp>
      <p:cxnSp>
        <p:nvCxnSpPr>
          <p:cNvPr id="20" name="Gerade Verbindung mit Pfeil 19">
            <a:extLst>
              <a:ext uri="{FF2B5EF4-FFF2-40B4-BE49-F238E27FC236}">
                <a16:creationId xmlns="" xmlns:a16="http://schemas.microsoft.com/office/drawing/2014/main" id="{8E1E28ED-C1BA-42B5-A515-2701C0BD2721}"/>
              </a:ext>
            </a:extLst>
          </p:cNvPr>
          <p:cNvCxnSpPr>
            <a:cxnSpLocks/>
          </p:cNvCxnSpPr>
          <p:nvPr/>
        </p:nvCxnSpPr>
        <p:spPr>
          <a:xfrm>
            <a:off x="7317819" y="4472989"/>
            <a:ext cx="119115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621177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/>
          <p:cNvSpPr txBox="1"/>
          <p:nvPr/>
        </p:nvSpPr>
        <p:spPr>
          <a:xfrm>
            <a:off x="9481001" y="6488668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Grafik 10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494" y="1080383"/>
            <a:ext cx="3596640" cy="43211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Grafik 12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47532" y="1080383"/>
            <a:ext cx="3528060" cy="42386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Grafik 13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8052" y="1080383"/>
            <a:ext cx="3459480" cy="4238625"/>
          </a:xfrm>
          <a:prstGeom prst="rect">
            <a:avLst/>
          </a:prstGeom>
          <a:noFill/>
          <a:ln>
            <a:noFill/>
          </a:ln>
        </p:spPr>
      </p:pic>
      <p:sp>
        <p:nvSpPr>
          <p:cNvPr id="15" name="Textfeld 14"/>
          <p:cNvSpPr txBox="1"/>
          <p:nvPr/>
        </p:nvSpPr>
        <p:spPr>
          <a:xfrm>
            <a:off x="2112885" y="452761"/>
            <a:ext cx="9164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D3+ T </a:t>
            </a:r>
            <a:r>
              <a:rPr lang="de-DE" dirty="0" err="1" smtClean="0"/>
              <a:t>cells</a:t>
            </a:r>
            <a:r>
              <a:rPr lang="de-DE" dirty="0" smtClean="0"/>
              <a:t> [%]                                    CD3+/CD4+ T </a:t>
            </a:r>
            <a:r>
              <a:rPr lang="de-DE" dirty="0" err="1" smtClean="0"/>
              <a:t>cells</a:t>
            </a:r>
            <a:r>
              <a:rPr lang="de-DE" dirty="0" smtClean="0"/>
              <a:t> [%]                          CD3+/CD8+ T </a:t>
            </a:r>
            <a:r>
              <a:rPr lang="de-DE" dirty="0" err="1" smtClean="0"/>
              <a:t>cells</a:t>
            </a:r>
            <a:r>
              <a:rPr lang="de-DE" dirty="0" smtClean="0"/>
              <a:t> [%]</a:t>
            </a:r>
            <a:endParaRPr lang="de-DE" dirty="0"/>
          </a:p>
        </p:txBody>
      </p:sp>
      <p:cxnSp>
        <p:nvCxnSpPr>
          <p:cNvPr id="16" name="Gerader Verbinder 15"/>
          <p:cNvCxnSpPr/>
          <p:nvPr/>
        </p:nvCxnSpPr>
        <p:spPr>
          <a:xfrm>
            <a:off x="5504156" y="1349407"/>
            <a:ext cx="214839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/>
          <p:cNvSpPr txBox="1"/>
          <p:nvPr/>
        </p:nvSpPr>
        <p:spPr>
          <a:xfrm>
            <a:off x="6417792" y="108038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1287454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feld 14"/>
          <p:cNvSpPr txBox="1"/>
          <p:nvPr/>
        </p:nvSpPr>
        <p:spPr>
          <a:xfrm>
            <a:off x="9481001" y="6488668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Grafik 10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055" y="1197035"/>
            <a:ext cx="3413760" cy="410146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Grafik 11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9314" y="1261170"/>
            <a:ext cx="3360420" cy="403733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7" name="Gerader Verbinder 16"/>
          <p:cNvCxnSpPr/>
          <p:nvPr/>
        </p:nvCxnSpPr>
        <p:spPr>
          <a:xfrm>
            <a:off x="1189608" y="1544715"/>
            <a:ext cx="214839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/>
          <p:cNvCxnSpPr/>
          <p:nvPr/>
        </p:nvCxnSpPr>
        <p:spPr>
          <a:xfrm flipV="1">
            <a:off x="5248182" y="1677880"/>
            <a:ext cx="2058140" cy="147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Grafik 18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37546" y="1261171"/>
            <a:ext cx="3093720" cy="4037330"/>
          </a:xfrm>
          <a:prstGeom prst="rect">
            <a:avLst/>
          </a:prstGeom>
          <a:noFill/>
          <a:ln>
            <a:noFill/>
          </a:ln>
        </p:spPr>
      </p:pic>
      <p:sp>
        <p:nvSpPr>
          <p:cNvPr id="20" name="Textfeld 19"/>
          <p:cNvSpPr txBox="1"/>
          <p:nvPr/>
        </p:nvSpPr>
        <p:spPr>
          <a:xfrm>
            <a:off x="710215" y="701337"/>
            <a:ext cx="10351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56+/CD94+ NK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[%]                        CD3-/CD69+ NK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[%]                 CD3-/CD56+ NK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[%]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6079524" y="141834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22" name="Textfeld 21"/>
          <p:cNvSpPr txBox="1"/>
          <p:nvPr/>
        </p:nvSpPr>
        <p:spPr>
          <a:xfrm>
            <a:off x="2075935" y="128191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5423301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9481001" y="6488668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Grafik 8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256" y="1198486"/>
            <a:ext cx="3291205" cy="4425652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Grafik 9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2999" y="1198485"/>
            <a:ext cx="3276600" cy="452760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Grafik 10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05559" y="1198485"/>
            <a:ext cx="3421380" cy="4425653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Textfeld 11"/>
          <p:cNvSpPr txBox="1"/>
          <p:nvPr/>
        </p:nvSpPr>
        <p:spPr>
          <a:xfrm>
            <a:off x="834501" y="745725"/>
            <a:ext cx="10200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-/NKG2D+ NK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[%]                CD3-/NKp30+ NK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[%]                CD3-/NKp46+ NK </a:t>
            </a:r>
            <a:r>
              <a:rPr lang="de-D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[%]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4004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9481001" y="6488668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Diagramm 12">
            <a:extLst>
              <a:ext uri="{FF2B5EF4-FFF2-40B4-BE49-F238E27FC236}">
                <a16:creationId xmlns:wpc="http://schemas.microsoft.com/office/word/2010/wordprocessingCanvas" xmlns:mc="http://schemas.openxmlformats.org/markup-compatibility/2006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a16="http://schemas.microsoft.com/office/drawing/2014/main" xmlns:lc="http://schemas.openxmlformats.org/drawingml/2006/lockedCanvas" id="{7564AA3F-84C3-4AE4-AA9C-15FFB35E8F3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44240099"/>
              </p:ext>
            </p:extLst>
          </p:nvPr>
        </p:nvGraphicFramePr>
        <p:xfrm>
          <a:off x="282488" y="377710"/>
          <a:ext cx="5599611" cy="266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Diagramm 13">
            <a:extLst>
              <a:ext uri="{FF2B5EF4-FFF2-40B4-BE49-F238E27FC236}">
                <a16:creationId xmlns:wpc="http://schemas.microsoft.com/office/word/2010/wordprocessingCanvas" xmlns:mc="http://schemas.openxmlformats.org/markup-compatibility/2006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a16="http://schemas.microsoft.com/office/drawing/2014/main" xmlns:lc="http://schemas.openxmlformats.org/drawingml/2006/lockedCanvas" id="{ED39D4CE-75F0-4343-8788-8178F4549C4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59201524"/>
              </p:ext>
            </p:extLst>
          </p:nvPr>
        </p:nvGraphicFramePr>
        <p:xfrm>
          <a:off x="282488" y="3620316"/>
          <a:ext cx="5607230" cy="26479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" name="Textfeld 6"/>
          <p:cNvSpPr txBox="1"/>
          <p:nvPr/>
        </p:nvSpPr>
        <p:spPr>
          <a:xfrm>
            <a:off x="4028259" y="3920252"/>
            <a:ext cx="495300" cy="3886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Diagramm 15">
            <a:extLst>
              <a:ext uri="{FF2B5EF4-FFF2-40B4-BE49-F238E27FC236}">
                <a16:creationId xmlns:wpc="http://schemas.microsoft.com/office/word/2010/wordprocessingCanvas" xmlns:mc="http://schemas.openxmlformats.org/markup-compatibility/2006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aink="http://schemas.microsoft.com/office/drawing/2016/ink" xmlns:am3d="http://schemas.microsoft.com/office/drawing/2017/model3d" xmlns:o="urn:schemas-microsoft-com:office:office" xmlns:v="urn:schemas-microsoft-com:vml" xmlns:w10="urn:schemas-microsoft-com:office:word" xmlns:w="http://schemas.openxmlformats.org/wordprocessingml/2006/main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a16="http://schemas.microsoft.com/office/drawing/2014/main" xmlns:lc="http://schemas.openxmlformats.org/drawingml/2006/lockedCanvas" id="{B52EF880-B929-4FAE-A1FB-FB959471252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761937214"/>
              </p:ext>
            </p:extLst>
          </p:nvPr>
        </p:nvGraphicFramePr>
        <p:xfrm>
          <a:off x="6518501" y="2355533"/>
          <a:ext cx="5011648" cy="31308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" name="Textfeld 16"/>
          <p:cNvSpPr txBox="1"/>
          <p:nvPr/>
        </p:nvSpPr>
        <p:spPr>
          <a:xfrm>
            <a:off x="113211" y="13821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6431416" y="198620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13211" y="336625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Grafik 19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7317" y="4234973"/>
            <a:ext cx="966653" cy="492047"/>
          </a:xfrm>
          <a:prstGeom prst="rect">
            <a:avLst/>
          </a:prstGeom>
          <a:noFill/>
        </p:spPr>
      </p:pic>
      <p:sp>
        <p:nvSpPr>
          <p:cNvPr id="21" name="Rechteck 20"/>
          <p:cNvSpPr/>
          <p:nvPr/>
        </p:nvSpPr>
        <p:spPr>
          <a:xfrm>
            <a:off x="4408102" y="4160813"/>
            <a:ext cx="429030" cy="2264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Textfeld 21"/>
          <p:cNvSpPr txBox="1"/>
          <p:nvPr/>
        </p:nvSpPr>
        <p:spPr>
          <a:xfrm>
            <a:off x="4409317" y="411166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*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665114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2160" y="1395264"/>
            <a:ext cx="4249782" cy="4352458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9166" y="1389481"/>
            <a:ext cx="4258491" cy="4358241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8490857" y="2255520"/>
            <a:ext cx="12153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D3-/CD56+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4052738" y="2255519"/>
            <a:ext cx="12153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D3-/CD94+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828800" y="15588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6187440" y="160416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9481001" y="6488668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6625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9</Words>
  <Application>Microsoft Office PowerPoint</Application>
  <PresentationFormat>Breitbild</PresentationFormat>
  <Paragraphs>43</Paragraphs>
  <Slides>7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efang Stangl</dc:creator>
  <cp:lastModifiedBy>Multhoff, Gabriele</cp:lastModifiedBy>
  <cp:revision>32</cp:revision>
  <cp:lastPrinted>2021-01-22T09:15:43Z</cp:lastPrinted>
  <dcterms:created xsi:type="dcterms:W3CDTF">2021-01-21T16:06:00Z</dcterms:created>
  <dcterms:modified xsi:type="dcterms:W3CDTF">2021-04-09T12:43:56Z</dcterms:modified>
</cp:coreProperties>
</file>